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61" r:id="rId2"/>
  </p:sldIdLst>
  <p:sldSz cx="9359900" cy="5400675"/>
  <p:notesSz cx="6858000" cy="9144000"/>
  <p:defaultTextStyle>
    <a:defPPr>
      <a:defRPr lang="pt-PT"/>
    </a:defPPr>
    <a:lvl1pPr marL="0" algn="l" defTabSz="853318" rtl="0" eaLnBrk="1" latinLnBrk="0" hangingPunct="1">
      <a:defRPr sz="1680" kern="1200">
        <a:solidFill>
          <a:schemeClr val="tx1"/>
        </a:solidFill>
        <a:latin typeface="+mn-lt"/>
        <a:ea typeface="+mn-ea"/>
        <a:cs typeface="+mn-cs"/>
      </a:defRPr>
    </a:lvl1pPr>
    <a:lvl2pPr marL="426659" algn="l" defTabSz="853318" rtl="0" eaLnBrk="1" latinLnBrk="0" hangingPunct="1">
      <a:defRPr sz="1680" kern="1200">
        <a:solidFill>
          <a:schemeClr val="tx1"/>
        </a:solidFill>
        <a:latin typeface="+mn-lt"/>
        <a:ea typeface="+mn-ea"/>
        <a:cs typeface="+mn-cs"/>
      </a:defRPr>
    </a:lvl2pPr>
    <a:lvl3pPr marL="853318" algn="l" defTabSz="853318" rtl="0" eaLnBrk="1" latinLnBrk="0" hangingPunct="1">
      <a:defRPr sz="1680" kern="1200">
        <a:solidFill>
          <a:schemeClr val="tx1"/>
        </a:solidFill>
        <a:latin typeface="+mn-lt"/>
        <a:ea typeface="+mn-ea"/>
        <a:cs typeface="+mn-cs"/>
      </a:defRPr>
    </a:lvl3pPr>
    <a:lvl4pPr marL="1279977" algn="l" defTabSz="853318" rtl="0" eaLnBrk="1" latinLnBrk="0" hangingPunct="1">
      <a:defRPr sz="1680" kern="1200">
        <a:solidFill>
          <a:schemeClr val="tx1"/>
        </a:solidFill>
        <a:latin typeface="+mn-lt"/>
        <a:ea typeface="+mn-ea"/>
        <a:cs typeface="+mn-cs"/>
      </a:defRPr>
    </a:lvl4pPr>
    <a:lvl5pPr marL="1706636" algn="l" defTabSz="853318" rtl="0" eaLnBrk="1" latinLnBrk="0" hangingPunct="1">
      <a:defRPr sz="1680" kern="1200">
        <a:solidFill>
          <a:schemeClr val="tx1"/>
        </a:solidFill>
        <a:latin typeface="+mn-lt"/>
        <a:ea typeface="+mn-ea"/>
        <a:cs typeface="+mn-cs"/>
      </a:defRPr>
    </a:lvl5pPr>
    <a:lvl6pPr marL="2133295" algn="l" defTabSz="853318" rtl="0" eaLnBrk="1" latinLnBrk="0" hangingPunct="1">
      <a:defRPr sz="1680" kern="1200">
        <a:solidFill>
          <a:schemeClr val="tx1"/>
        </a:solidFill>
        <a:latin typeface="+mn-lt"/>
        <a:ea typeface="+mn-ea"/>
        <a:cs typeface="+mn-cs"/>
      </a:defRPr>
    </a:lvl6pPr>
    <a:lvl7pPr marL="2559954" algn="l" defTabSz="853318" rtl="0" eaLnBrk="1" latinLnBrk="0" hangingPunct="1">
      <a:defRPr sz="1680" kern="1200">
        <a:solidFill>
          <a:schemeClr val="tx1"/>
        </a:solidFill>
        <a:latin typeface="+mn-lt"/>
        <a:ea typeface="+mn-ea"/>
        <a:cs typeface="+mn-cs"/>
      </a:defRPr>
    </a:lvl7pPr>
    <a:lvl8pPr marL="2986613" algn="l" defTabSz="853318" rtl="0" eaLnBrk="1" latinLnBrk="0" hangingPunct="1">
      <a:defRPr sz="1680" kern="1200">
        <a:solidFill>
          <a:schemeClr val="tx1"/>
        </a:solidFill>
        <a:latin typeface="+mn-lt"/>
        <a:ea typeface="+mn-ea"/>
        <a:cs typeface="+mn-cs"/>
      </a:defRPr>
    </a:lvl8pPr>
    <a:lvl9pPr marL="3413272" algn="l" defTabSz="853318" rtl="0" eaLnBrk="1" latinLnBrk="0" hangingPunct="1">
      <a:defRPr sz="168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98" d="100"/>
          <a:sy n="98" d="100"/>
        </p:scale>
        <p:origin x="1890" y="9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69988" y="883861"/>
            <a:ext cx="7019925" cy="1880235"/>
          </a:xfrm>
        </p:spPr>
        <p:txBody>
          <a:bodyPr anchor="b"/>
          <a:lstStyle>
            <a:lvl1pPr algn="ctr">
              <a:defRPr sz="4606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9988" y="2836605"/>
            <a:ext cx="7019925" cy="1303913"/>
          </a:xfrm>
        </p:spPr>
        <p:txBody>
          <a:bodyPr/>
          <a:lstStyle>
            <a:lvl1pPr marL="0" indent="0" algn="ctr">
              <a:buNone/>
              <a:defRPr sz="1842"/>
            </a:lvl1pPr>
            <a:lvl2pPr marL="350992" indent="0" algn="ctr">
              <a:buNone/>
              <a:defRPr sz="1535"/>
            </a:lvl2pPr>
            <a:lvl3pPr marL="701985" indent="0" algn="ctr">
              <a:buNone/>
              <a:defRPr sz="1382"/>
            </a:lvl3pPr>
            <a:lvl4pPr marL="1052977" indent="0" algn="ctr">
              <a:buNone/>
              <a:defRPr sz="1228"/>
            </a:lvl4pPr>
            <a:lvl5pPr marL="1403970" indent="0" algn="ctr">
              <a:buNone/>
              <a:defRPr sz="1228"/>
            </a:lvl5pPr>
            <a:lvl6pPr marL="1754962" indent="0" algn="ctr">
              <a:buNone/>
              <a:defRPr sz="1228"/>
            </a:lvl6pPr>
            <a:lvl7pPr marL="2105955" indent="0" algn="ctr">
              <a:buNone/>
              <a:defRPr sz="1228"/>
            </a:lvl7pPr>
            <a:lvl8pPr marL="2456947" indent="0" algn="ctr">
              <a:buNone/>
              <a:defRPr sz="1228"/>
            </a:lvl8pPr>
            <a:lvl9pPr marL="2807940" indent="0" algn="ctr">
              <a:buNone/>
              <a:defRPr sz="1228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04BF2-2B3B-4618-AF0A-FF9661B83824}" type="datetimeFigureOut">
              <a:rPr lang="pt-PT" smtClean="0"/>
              <a:t>30/01/2019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839EC-A923-4F2E-B6C2-3840F3F957D3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6989862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04BF2-2B3B-4618-AF0A-FF9661B83824}" type="datetimeFigureOut">
              <a:rPr lang="pt-PT" smtClean="0"/>
              <a:t>30/01/2019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839EC-A923-4F2E-B6C2-3840F3F957D3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6159098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98179" y="287536"/>
            <a:ext cx="2018228" cy="457682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43493" y="287536"/>
            <a:ext cx="5937687" cy="4576822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04BF2-2B3B-4618-AF0A-FF9661B83824}" type="datetimeFigureOut">
              <a:rPr lang="pt-PT" smtClean="0"/>
              <a:t>30/01/2019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839EC-A923-4F2E-B6C2-3840F3F957D3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13619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04BF2-2B3B-4618-AF0A-FF9661B83824}" type="datetimeFigureOut">
              <a:rPr lang="pt-PT" smtClean="0"/>
              <a:t>30/01/2019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839EC-A923-4F2E-B6C2-3840F3F957D3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0474303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8618" y="1346419"/>
            <a:ext cx="8072914" cy="2246530"/>
          </a:xfrm>
        </p:spPr>
        <p:txBody>
          <a:bodyPr anchor="b"/>
          <a:lstStyle>
            <a:lvl1pPr>
              <a:defRPr sz="4606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8618" y="3614203"/>
            <a:ext cx="8072914" cy="1181397"/>
          </a:xfrm>
        </p:spPr>
        <p:txBody>
          <a:bodyPr/>
          <a:lstStyle>
            <a:lvl1pPr marL="0" indent="0">
              <a:buNone/>
              <a:defRPr sz="1842">
                <a:solidFill>
                  <a:schemeClr val="tx1">
                    <a:tint val="75000"/>
                  </a:schemeClr>
                </a:solidFill>
              </a:defRPr>
            </a:lvl1pPr>
            <a:lvl2pPr marL="350992" indent="0">
              <a:buNone/>
              <a:defRPr sz="1535">
                <a:solidFill>
                  <a:schemeClr val="tx1">
                    <a:tint val="75000"/>
                  </a:schemeClr>
                </a:solidFill>
              </a:defRPr>
            </a:lvl2pPr>
            <a:lvl3pPr marL="701985" indent="0">
              <a:buNone/>
              <a:defRPr sz="1382">
                <a:solidFill>
                  <a:schemeClr val="tx1">
                    <a:tint val="75000"/>
                  </a:schemeClr>
                </a:solidFill>
              </a:defRPr>
            </a:lvl3pPr>
            <a:lvl4pPr marL="1052977" indent="0">
              <a:buNone/>
              <a:defRPr sz="1228">
                <a:solidFill>
                  <a:schemeClr val="tx1">
                    <a:tint val="75000"/>
                  </a:schemeClr>
                </a:solidFill>
              </a:defRPr>
            </a:lvl4pPr>
            <a:lvl5pPr marL="1403970" indent="0">
              <a:buNone/>
              <a:defRPr sz="1228">
                <a:solidFill>
                  <a:schemeClr val="tx1">
                    <a:tint val="75000"/>
                  </a:schemeClr>
                </a:solidFill>
              </a:defRPr>
            </a:lvl5pPr>
            <a:lvl6pPr marL="1754962" indent="0">
              <a:buNone/>
              <a:defRPr sz="1228">
                <a:solidFill>
                  <a:schemeClr val="tx1">
                    <a:tint val="75000"/>
                  </a:schemeClr>
                </a:solidFill>
              </a:defRPr>
            </a:lvl6pPr>
            <a:lvl7pPr marL="2105955" indent="0">
              <a:buNone/>
              <a:defRPr sz="1228">
                <a:solidFill>
                  <a:schemeClr val="tx1">
                    <a:tint val="75000"/>
                  </a:schemeClr>
                </a:solidFill>
              </a:defRPr>
            </a:lvl7pPr>
            <a:lvl8pPr marL="2456947" indent="0">
              <a:buNone/>
              <a:defRPr sz="1228">
                <a:solidFill>
                  <a:schemeClr val="tx1">
                    <a:tint val="75000"/>
                  </a:schemeClr>
                </a:solidFill>
              </a:defRPr>
            </a:lvl8pPr>
            <a:lvl9pPr marL="2807940" indent="0">
              <a:buNone/>
              <a:defRPr sz="122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04BF2-2B3B-4618-AF0A-FF9661B83824}" type="datetimeFigureOut">
              <a:rPr lang="pt-PT" smtClean="0"/>
              <a:t>30/01/2019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839EC-A923-4F2E-B6C2-3840F3F957D3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879119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43493" y="1437680"/>
            <a:ext cx="3977958" cy="34266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38449" y="1437680"/>
            <a:ext cx="3977958" cy="34266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04BF2-2B3B-4618-AF0A-FF9661B83824}" type="datetimeFigureOut">
              <a:rPr lang="pt-PT" smtClean="0"/>
              <a:t>30/01/2019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839EC-A923-4F2E-B6C2-3840F3F957D3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772870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4712" y="287536"/>
            <a:ext cx="8072914" cy="1043881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4713" y="1323916"/>
            <a:ext cx="3959676" cy="648831"/>
          </a:xfrm>
        </p:spPr>
        <p:txBody>
          <a:bodyPr anchor="b"/>
          <a:lstStyle>
            <a:lvl1pPr marL="0" indent="0">
              <a:buNone/>
              <a:defRPr sz="1842" b="1"/>
            </a:lvl1pPr>
            <a:lvl2pPr marL="350992" indent="0">
              <a:buNone/>
              <a:defRPr sz="1535" b="1"/>
            </a:lvl2pPr>
            <a:lvl3pPr marL="701985" indent="0">
              <a:buNone/>
              <a:defRPr sz="1382" b="1"/>
            </a:lvl3pPr>
            <a:lvl4pPr marL="1052977" indent="0">
              <a:buNone/>
              <a:defRPr sz="1228" b="1"/>
            </a:lvl4pPr>
            <a:lvl5pPr marL="1403970" indent="0">
              <a:buNone/>
              <a:defRPr sz="1228" b="1"/>
            </a:lvl5pPr>
            <a:lvl6pPr marL="1754962" indent="0">
              <a:buNone/>
              <a:defRPr sz="1228" b="1"/>
            </a:lvl6pPr>
            <a:lvl7pPr marL="2105955" indent="0">
              <a:buNone/>
              <a:defRPr sz="1228" b="1"/>
            </a:lvl7pPr>
            <a:lvl8pPr marL="2456947" indent="0">
              <a:buNone/>
              <a:defRPr sz="1228" b="1"/>
            </a:lvl8pPr>
            <a:lvl9pPr marL="2807940" indent="0">
              <a:buNone/>
              <a:defRPr sz="1228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4713" y="1972747"/>
            <a:ext cx="3959676" cy="290161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738449" y="1323916"/>
            <a:ext cx="3979177" cy="648831"/>
          </a:xfrm>
        </p:spPr>
        <p:txBody>
          <a:bodyPr anchor="b"/>
          <a:lstStyle>
            <a:lvl1pPr marL="0" indent="0">
              <a:buNone/>
              <a:defRPr sz="1842" b="1"/>
            </a:lvl1pPr>
            <a:lvl2pPr marL="350992" indent="0">
              <a:buNone/>
              <a:defRPr sz="1535" b="1"/>
            </a:lvl2pPr>
            <a:lvl3pPr marL="701985" indent="0">
              <a:buNone/>
              <a:defRPr sz="1382" b="1"/>
            </a:lvl3pPr>
            <a:lvl4pPr marL="1052977" indent="0">
              <a:buNone/>
              <a:defRPr sz="1228" b="1"/>
            </a:lvl4pPr>
            <a:lvl5pPr marL="1403970" indent="0">
              <a:buNone/>
              <a:defRPr sz="1228" b="1"/>
            </a:lvl5pPr>
            <a:lvl6pPr marL="1754962" indent="0">
              <a:buNone/>
              <a:defRPr sz="1228" b="1"/>
            </a:lvl6pPr>
            <a:lvl7pPr marL="2105955" indent="0">
              <a:buNone/>
              <a:defRPr sz="1228" b="1"/>
            </a:lvl7pPr>
            <a:lvl8pPr marL="2456947" indent="0">
              <a:buNone/>
              <a:defRPr sz="1228" b="1"/>
            </a:lvl8pPr>
            <a:lvl9pPr marL="2807940" indent="0">
              <a:buNone/>
              <a:defRPr sz="1228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738449" y="1972747"/>
            <a:ext cx="3979177" cy="290161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04BF2-2B3B-4618-AF0A-FF9661B83824}" type="datetimeFigureOut">
              <a:rPr lang="pt-PT" smtClean="0"/>
              <a:t>30/01/2019</a:t>
            </a:fld>
            <a:endParaRPr lang="pt-P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839EC-A923-4F2E-B6C2-3840F3F957D3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1003138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04BF2-2B3B-4618-AF0A-FF9661B83824}" type="datetimeFigureOut">
              <a:rPr lang="pt-PT" smtClean="0"/>
              <a:t>30/01/2019</a:t>
            </a:fld>
            <a:endParaRPr lang="pt-P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839EC-A923-4F2E-B6C2-3840F3F957D3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802097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04BF2-2B3B-4618-AF0A-FF9661B83824}" type="datetimeFigureOut">
              <a:rPr lang="pt-PT" smtClean="0"/>
              <a:t>30/01/2019</a:t>
            </a:fld>
            <a:endParaRPr lang="pt-P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839EC-A923-4F2E-B6C2-3840F3F957D3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0532121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4713" y="360045"/>
            <a:ext cx="3018811" cy="1260158"/>
          </a:xfrm>
        </p:spPr>
        <p:txBody>
          <a:bodyPr anchor="b"/>
          <a:lstStyle>
            <a:lvl1pPr>
              <a:defRPr sz="245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79177" y="777597"/>
            <a:ext cx="4738449" cy="3837980"/>
          </a:xfrm>
        </p:spPr>
        <p:txBody>
          <a:bodyPr/>
          <a:lstStyle>
            <a:lvl1pPr>
              <a:defRPr sz="2457"/>
            </a:lvl1pPr>
            <a:lvl2pPr>
              <a:defRPr sz="2150"/>
            </a:lvl2pPr>
            <a:lvl3pPr>
              <a:defRPr sz="1842"/>
            </a:lvl3pPr>
            <a:lvl4pPr>
              <a:defRPr sz="1535"/>
            </a:lvl4pPr>
            <a:lvl5pPr>
              <a:defRPr sz="1535"/>
            </a:lvl5pPr>
            <a:lvl6pPr>
              <a:defRPr sz="1535"/>
            </a:lvl6pPr>
            <a:lvl7pPr>
              <a:defRPr sz="1535"/>
            </a:lvl7pPr>
            <a:lvl8pPr>
              <a:defRPr sz="1535"/>
            </a:lvl8pPr>
            <a:lvl9pPr>
              <a:defRPr sz="1535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4713" y="1620202"/>
            <a:ext cx="3018811" cy="3001626"/>
          </a:xfrm>
        </p:spPr>
        <p:txBody>
          <a:bodyPr/>
          <a:lstStyle>
            <a:lvl1pPr marL="0" indent="0">
              <a:buNone/>
              <a:defRPr sz="1228"/>
            </a:lvl1pPr>
            <a:lvl2pPr marL="350992" indent="0">
              <a:buNone/>
              <a:defRPr sz="1075"/>
            </a:lvl2pPr>
            <a:lvl3pPr marL="701985" indent="0">
              <a:buNone/>
              <a:defRPr sz="921"/>
            </a:lvl3pPr>
            <a:lvl4pPr marL="1052977" indent="0">
              <a:buNone/>
              <a:defRPr sz="768"/>
            </a:lvl4pPr>
            <a:lvl5pPr marL="1403970" indent="0">
              <a:buNone/>
              <a:defRPr sz="768"/>
            </a:lvl5pPr>
            <a:lvl6pPr marL="1754962" indent="0">
              <a:buNone/>
              <a:defRPr sz="768"/>
            </a:lvl6pPr>
            <a:lvl7pPr marL="2105955" indent="0">
              <a:buNone/>
              <a:defRPr sz="768"/>
            </a:lvl7pPr>
            <a:lvl8pPr marL="2456947" indent="0">
              <a:buNone/>
              <a:defRPr sz="768"/>
            </a:lvl8pPr>
            <a:lvl9pPr marL="2807940" indent="0">
              <a:buNone/>
              <a:defRPr sz="768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04BF2-2B3B-4618-AF0A-FF9661B83824}" type="datetimeFigureOut">
              <a:rPr lang="pt-PT" smtClean="0"/>
              <a:t>30/01/2019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839EC-A923-4F2E-B6C2-3840F3F957D3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9432531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4713" y="360045"/>
            <a:ext cx="3018811" cy="1260158"/>
          </a:xfrm>
        </p:spPr>
        <p:txBody>
          <a:bodyPr anchor="b"/>
          <a:lstStyle>
            <a:lvl1pPr>
              <a:defRPr sz="245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979177" y="777597"/>
            <a:ext cx="4738449" cy="3837980"/>
          </a:xfrm>
        </p:spPr>
        <p:txBody>
          <a:bodyPr anchor="t"/>
          <a:lstStyle>
            <a:lvl1pPr marL="0" indent="0">
              <a:buNone/>
              <a:defRPr sz="2457"/>
            </a:lvl1pPr>
            <a:lvl2pPr marL="350992" indent="0">
              <a:buNone/>
              <a:defRPr sz="2150"/>
            </a:lvl2pPr>
            <a:lvl3pPr marL="701985" indent="0">
              <a:buNone/>
              <a:defRPr sz="1842"/>
            </a:lvl3pPr>
            <a:lvl4pPr marL="1052977" indent="0">
              <a:buNone/>
              <a:defRPr sz="1535"/>
            </a:lvl4pPr>
            <a:lvl5pPr marL="1403970" indent="0">
              <a:buNone/>
              <a:defRPr sz="1535"/>
            </a:lvl5pPr>
            <a:lvl6pPr marL="1754962" indent="0">
              <a:buNone/>
              <a:defRPr sz="1535"/>
            </a:lvl6pPr>
            <a:lvl7pPr marL="2105955" indent="0">
              <a:buNone/>
              <a:defRPr sz="1535"/>
            </a:lvl7pPr>
            <a:lvl8pPr marL="2456947" indent="0">
              <a:buNone/>
              <a:defRPr sz="1535"/>
            </a:lvl8pPr>
            <a:lvl9pPr marL="2807940" indent="0">
              <a:buNone/>
              <a:defRPr sz="1535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4713" y="1620202"/>
            <a:ext cx="3018811" cy="3001626"/>
          </a:xfrm>
        </p:spPr>
        <p:txBody>
          <a:bodyPr/>
          <a:lstStyle>
            <a:lvl1pPr marL="0" indent="0">
              <a:buNone/>
              <a:defRPr sz="1228"/>
            </a:lvl1pPr>
            <a:lvl2pPr marL="350992" indent="0">
              <a:buNone/>
              <a:defRPr sz="1075"/>
            </a:lvl2pPr>
            <a:lvl3pPr marL="701985" indent="0">
              <a:buNone/>
              <a:defRPr sz="921"/>
            </a:lvl3pPr>
            <a:lvl4pPr marL="1052977" indent="0">
              <a:buNone/>
              <a:defRPr sz="768"/>
            </a:lvl4pPr>
            <a:lvl5pPr marL="1403970" indent="0">
              <a:buNone/>
              <a:defRPr sz="768"/>
            </a:lvl5pPr>
            <a:lvl6pPr marL="1754962" indent="0">
              <a:buNone/>
              <a:defRPr sz="768"/>
            </a:lvl6pPr>
            <a:lvl7pPr marL="2105955" indent="0">
              <a:buNone/>
              <a:defRPr sz="768"/>
            </a:lvl7pPr>
            <a:lvl8pPr marL="2456947" indent="0">
              <a:buNone/>
              <a:defRPr sz="768"/>
            </a:lvl8pPr>
            <a:lvl9pPr marL="2807940" indent="0">
              <a:buNone/>
              <a:defRPr sz="768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04BF2-2B3B-4618-AF0A-FF9661B83824}" type="datetimeFigureOut">
              <a:rPr lang="pt-PT" smtClean="0"/>
              <a:t>30/01/2019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839EC-A923-4F2E-B6C2-3840F3F957D3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7755867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43493" y="287536"/>
            <a:ext cx="8072914" cy="104388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3493" y="1437680"/>
            <a:ext cx="8072914" cy="34266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43493" y="5005626"/>
            <a:ext cx="2105978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F04BF2-2B3B-4618-AF0A-FF9661B83824}" type="datetimeFigureOut">
              <a:rPr lang="pt-PT" smtClean="0"/>
              <a:t>30/01/2019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00467" y="5005626"/>
            <a:ext cx="3158966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610429" y="5005626"/>
            <a:ext cx="2105978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B839EC-A923-4F2E-B6C2-3840F3F957D3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9894793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701985" rtl="0" eaLnBrk="1" latinLnBrk="0" hangingPunct="1">
        <a:lnSpc>
          <a:spcPct val="90000"/>
        </a:lnSpc>
        <a:spcBef>
          <a:spcPct val="0"/>
        </a:spcBef>
        <a:buNone/>
        <a:defRPr sz="337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5496" indent="-175496" algn="l" defTabSz="701985" rtl="0" eaLnBrk="1" latinLnBrk="0" hangingPunct="1">
        <a:lnSpc>
          <a:spcPct val="90000"/>
        </a:lnSpc>
        <a:spcBef>
          <a:spcPts val="768"/>
        </a:spcBef>
        <a:buFont typeface="Arial" panose="020B0604020202020204" pitchFamily="34" charset="0"/>
        <a:buChar char="•"/>
        <a:defRPr sz="2150" kern="1200">
          <a:solidFill>
            <a:schemeClr val="tx1"/>
          </a:solidFill>
          <a:latin typeface="+mn-lt"/>
          <a:ea typeface="+mn-ea"/>
          <a:cs typeface="+mn-cs"/>
        </a:defRPr>
      </a:lvl1pPr>
      <a:lvl2pPr marL="526489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842" kern="1200">
          <a:solidFill>
            <a:schemeClr val="tx1"/>
          </a:solidFill>
          <a:latin typeface="+mn-lt"/>
          <a:ea typeface="+mn-ea"/>
          <a:cs typeface="+mn-cs"/>
        </a:defRPr>
      </a:lvl2pPr>
      <a:lvl3pPr marL="877481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535" kern="1200">
          <a:solidFill>
            <a:schemeClr val="tx1"/>
          </a:solidFill>
          <a:latin typeface="+mn-lt"/>
          <a:ea typeface="+mn-ea"/>
          <a:cs typeface="+mn-cs"/>
        </a:defRPr>
      </a:lvl3pPr>
      <a:lvl4pPr marL="1228474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382" kern="1200">
          <a:solidFill>
            <a:schemeClr val="tx1"/>
          </a:solidFill>
          <a:latin typeface="+mn-lt"/>
          <a:ea typeface="+mn-ea"/>
          <a:cs typeface="+mn-cs"/>
        </a:defRPr>
      </a:lvl4pPr>
      <a:lvl5pPr marL="1579466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382" kern="1200">
          <a:solidFill>
            <a:schemeClr val="tx1"/>
          </a:solidFill>
          <a:latin typeface="+mn-lt"/>
          <a:ea typeface="+mn-ea"/>
          <a:cs typeface="+mn-cs"/>
        </a:defRPr>
      </a:lvl5pPr>
      <a:lvl6pPr marL="1930458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382" kern="1200">
          <a:solidFill>
            <a:schemeClr val="tx1"/>
          </a:solidFill>
          <a:latin typeface="+mn-lt"/>
          <a:ea typeface="+mn-ea"/>
          <a:cs typeface="+mn-cs"/>
        </a:defRPr>
      </a:lvl6pPr>
      <a:lvl7pPr marL="2281451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382" kern="1200">
          <a:solidFill>
            <a:schemeClr val="tx1"/>
          </a:solidFill>
          <a:latin typeface="+mn-lt"/>
          <a:ea typeface="+mn-ea"/>
          <a:cs typeface="+mn-cs"/>
        </a:defRPr>
      </a:lvl7pPr>
      <a:lvl8pPr marL="2632443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382" kern="1200">
          <a:solidFill>
            <a:schemeClr val="tx1"/>
          </a:solidFill>
          <a:latin typeface="+mn-lt"/>
          <a:ea typeface="+mn-ea"/>
          <a:cs typeface="+mn-cs"/>
        </a:defRPr>
      </a:lvl8pPr>
      <a:lvl9pPr marL="2983436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38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1pPr>
      <a:lvl2pPr marL="350992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2pPr>
      <a:lvl3pPr marL="701985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3pPr>
      <a:lvl4pPr marL="1052977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4pPr>
      <a:lvl5pPr marL="1403970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5pPr>
      <a:lvl6pPr marL="1754962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6pPr>
      <a:lvl7pPr marL="2105955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7pPr>
      <a:lvl8pPr marL="2456947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8pPr>
      <a:lvl9pPr marL="2807940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f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4" name="Rectangle 153"/>
          <p:cNvSpPr/>
          <p:nvPr/>
        </p:nvSpPr>
        <p:spPr>
          <a:xfrm>
            <a:off x="266683" y="202379"/>
            <a:ext cx="8967846" cy="507001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pic>
        <p:nvPicPr>
          <p:cNvPr id="155" name="Picture 154" descr="venny_1_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377440" y="2393482"/>
            <a:ext cx="3240000" cy="2594569"/>
          </a:xfrm>
          <a:prstGeom prst="rect">
            <a:avLst/>
          </a:prstGeom>
        </p:spPr>
      </p:pic>
      <p:sp>
        <p:nvSpPr>
          <p:cNvPr id="156" name="Oval 155"/>
          <p:cNvSpPr/>
          <p:nvPr/>
        </p:nvSpPr>
        <p:spPr>
          <a:xfrm>
            <a:off x="2381111" y="2788750"/>
            <a:ext cx="339865" cy="169932"/>
          </a:xfrm>
          <a:prstGeom prst="ellipse">
            <a:avLst/>
          </a:prstGeom>
          <a:noFill/>
          <a:ln>
            <a:solidFill>
              <a:srgbClr val="0066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grpSp>
        <p:nvGrpSpPr>
          <p:cNvPr id="157" name="Group 81"/>
          <p:cNvGrpSpPr/>
          <p:nvPr/>
        </p:nvGrpSpPr>
        <p:grpSpPr>
          <a:xfrm>
            <a:off x="301197" y="2245727"/>
            <a:ext cx="466957" cy="360000"/>
            <a:chOff x="528125" y="1390694"/>
            <a:chExt cx="466957" cy="360000"/>
          </a:xfrm>
        </p:grpSpPr>
        <p:pic>
          <p:nvPicPr>
            <p:cNvPr id="158" name="Picture 157" descr="MonoCSC.tif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528125" y="1390694"/>
              <a:ext cx="466957" cy="360000"/>
            </a:xfrm>
            <a:prstGeom prst="rect">
              <a:avLst/>
            </a:prstGeom>
          </p:spPr>
        </p:pic>
        <p:pic>
          <p:nvPicPr>
            <p:cNvPr id="159" name="Picture 4" descr="Resultado de imagem para lightning bolt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671603" y="1415975"/>
              <a:ext cx="180000" cy="180000"/>
            </a:xfrm>
            <a:prstGeom prst="rect">
              <a:avLst/>
            </a:prstGeom>
            <a:noFill/>
          </p:spPr>
        </p:pic>
      </p:grpSp>
      <p:grpSp>
        <p:nvGrpSpPr>
          <p:cNvPr id="160" name="Group 84"/>
          <p:cNvGrpSpPr/>
          <p:nvPr/>
        </p:nvGrpSpPr>
        <p:grpSpPr>
          <a:xfrm>
            <a:off x="3126826" y="2245727"/>
            <a:ext cx="466957" cy="360000"/>
            <a:chOff x="1177586" y="1390694"/>
            <a:chExt cx="466957" cy="360000"/>
          </a:xfrm>
        </p:grpSpPr>
        <p:pic>
          <p:nvPicPr>
            <p:cNvPr id="161" name="Picture 160" descr="Co.tif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1177586" y="1390694"/>
              <a:ext cx="466957" cy="360000"/>
            </a:xfrm>
            <a:prstGeom prst="rect">
              <a:avLst/>
            </a:prstGeom>
          </p:spPr>
        </p:pic>
        <p:pic>
          <p:nvPicPr>
            <p:cNvPr id="162" name="Picture 4" descr="Resultado de imagem para lightning bolt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1321916" y="1415975"/>
              <a:ext cx="180000" cy="180000"/>
            </a:xfrm>
            <a:prstGeom prst="rect">
              <a:avLst/>
            </a:prstGeom>
            <a:noFill/>
          </p:spPr>
        </p:pic>
      </p:grpSp>
      <p:pic>
        <p:nvPicPr>
          <p:cNvPr id="163" name="Picture 162" descr="MonoCSC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301197" y="4614654"/>
            <a:ext cx="466957" cy="360000"/>
          </a:xfrm>
          <a:prstGeom prst="rect">
            <a:avLst/>
          </a:prstGeom>
        </p:spPr>
      </p:pic>
      <p:pic>
        <p:nvPicPr>
          <p:cNvPr id="164" name="Picture 163" descr="Co.tif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3126826" y="4614654"/>
            <a:ext cx="466957" cy="360000"/>
          </a:xfrm>
          <a:prstGeom prst="rect">
            <a:avLst/>
          </a:prstGeom>
        </p:spPr>
      </p:pic>
      <p:sp>
        <p:nvSpPr>
          <p:cNvPr id="165" name="TextBox 164"/>
          <p:cNvSpPr txBox="1"/>
          <p:nvPr/>
        </p:nvSpPr>
        <p:spPr>
          <a:xfrm>
            <a:off x="769496" y="2363569"/>
            <a:ext cx="68470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 smtClean="0">
                <a:solidFill>
                  <a:schemeClr val="accent2">
                    <a:lumMod val="50000"/>
                  </a:schemeClr>
                </a:solidFill>
              </a:rPr>
              <a:t>M CPC </a:t>
            </a:r>
            <a:r>
              <a:rPr lang="en-US" sz="1050" b="1" dirty="0" err="1" smtClean="0">
                <a:solidFill>
                  <a:schemeClr val="accent2">
                    <a:lumMod val="50000"/>
                  </a:schemeClr>
                </a:solidFill>
              </a:rPr>
              <a:t>i</a:t>
            </a:r>
            <a:endParaRPr lang="pt-PT" sz="1050" b="1" dirty="0">
              <a:solidFill>
                <a:schemeClr val="accent2">
                  <a:lumMod val="50000"/>
                </a:schemeClr>
              </a:solidFill>
            </a:endParaRPr>
          </a:p>
        </p:txBody>
      </p:sp>
      <p:sp>
        <p:nvSpPr>
          <p:cNvPr id="166" name="TextBox 165"/>
          <p:cNvSpPr txBox="1"/>
          <p:nvPr/>
        </p:nvSpPr>
        <p:spPr>
          <a:xfrm>
            <a:off x="2420195" y="2371441"/>
            <a:ext cx="68470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 smtClean="0">
                <a:solidFill>
                  <a:srgbClr val="006600"/>
                </a:solidFill>
              </a:rPr>
              <a:t>Co CPC </a:t>
            </a:r>
            <a:r>
              <a:rPr lang="en-US" sz="1050" b="1" dirty="0" err="1" smtClean="0">
                <a:solidFill>
                  <a:srgbClr val="006600"/>
                </a:solidFill>
              </a:rPr>
              <a:t>i</a:t>
            </a:r>
            <a:endParaRPr lang="pt-PT" sz="1050" b="1" dirty="0">
              <a:solidFill>
                <a:srgbClr val="006600"/>
              </a:solidFill>
            </a:endParaRPr>
          </a:p>
        </p:txBody>
      </p:sp>
      <p:sp>
        <p:nvSpPr>
          <p:cNvPr id="167" name="Rectangle 166"/>
          <p:cNvSpPr/>
          <p:nvPr/>
        </p:nvSpPr>
        <p:spPr>
          <a:xfrm>
            <a:off x="2936102" y="4537537"/>
            <a:ext cx="670107" cy="15073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68" name="TextBox 167"/>
          <p:cNvSpPr txBox="1"/>
          <p:nvPr/>
        </p:nvSpPr>
        <p:spPr>
          <a:xfrm>
            <a:off x="2801743" y="4468893"/>
            <a:ext cx="8916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Co CPC CTL</a:t>
            </a:r>
            <a:endParaRPr lang="pt-PT" sz="1050" b="1" dirty="0">
              <a:solidFill>
                <a:schemeClr val="tx1">
                  <a:lumMod val="65000"/>
                  <a:lumOff val="35000"/>
                </a:schemeClr>
              </a:solidFill>
            </a:endParaRPr>
          </a:p>
        </p:txBody>
      </p:sp>
      <p:sp>
        <p:nvSpPr>
          <p:cNvPr id="169" name="Rectangle 168"/>
          <p:cNvSpPr/>
          <p:nvPr/>
        </p:nvSpPr>
        <p:spPr>
          <a:xfrm>
            <a:off x="377440" y="4517253"/>
            <a:ext cx="670107" cy="15073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70" name="TextBox 169"/>
          <p:cNvSpPr txBox="1"/>
          <p:nvPr/>
        </p:nvSpPr>
        <p:spPr>
          <a:xfrm>
            <a:off x="266682" y="4468893"/>
            <a:ext cx="8916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 smtClean="0"/>
              <a:t>M CPC CTL</a:t>
            </a:r>
            <a:endParaRPr lang="pt-PT" sz="1050" b="1" dirty="0"/>
          </a:p>
        </p:txBody>
      </p:sp>
      <p:sp>
        <p:nvSpPr>
          <p:cNvPr id="171" name="TextBox 170"/>
          <p:cNvSpPr txBox="1"/>
          <p:nvPr/>
        </p:nvSpPr>
        <p:spPr>
          <a:xfrm>
            <a:off x="4009496" y="202379"/>
            <a:ext cx="41063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600" b="1" dirty="0" smtClean="0">
                <a:solidFill>
                  <a:srgbClr val="006600"/>
                </a:solidFill>
              </a:rPr>
              <a:t>Proteins associated with:</a:t>
            </a:r>
            <a:endParaRPr lang="pt-PT" sz="1600" b="1" dirty="0">
              <a:solidFill>
                <a:srgbClr val="006600"/>
              </a:solidFill>
            </a:endParaRPr>
          </a:p>
        </p:txBody>
      </p:sp>
      <p:sp>
        <p:nvSpPr>
          <p:cNvPr id="172" name="Rectangle 171"/>
          <p:cNvSpPr/>
          <p:nvPr/>
        </p:nvSpPr>
        <p:spPr>
          <a:xfrm>
            <a:off x="3851196" y="540933"/>
            <a:ext cx="46134" cy="4680000"/>
          </a:xfrm>
          <a:prstGeom prst="rect">
            <a:avLst/>
          </a:prstGeom>
          <a:solidFill>
            <a:srgbClr val="0066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 sz="2000"/>
          </a:p>
        </p:txBody>
      </p:sp>
      <p:cxnSp>
        <p:nvCxnSpPr>
          <p:cNvPr id="173" name="Straight Connector 172"/>
          <p:cNvCxnSpPr>
            <a:stCxn id="172" idx="3"/>
            <a:endCxn id="156" idx="6"/>
          </p:cNvCxnSpPr>
          <p:nvPr/>
        </p:nvCxnSpPr>
        <p:spPr>
          <a:xfrm flipH="1" flipV="1">
            <a:off x="2720976" y="2873716"/>
            <a:ext cx="1176354" cy="7217"/>
          </a:xfrm>
          <a:prstGeom prst="line">
            <a:avLst/>
          </a:prstGeom>
          <a:ln w="12700">
            <a:solidFill>
              <a:srgbClr val="0066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74" name="Table 17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45543816"/>
              </p:ext>
            </p:extLst>
          </p:nvPr>
        </p:nvGraphicFramePr>
        <p:xfrm>
          <a:off x="4009496" y="650040"/>
          <a:ext cx="5108888" cy="4570893"/>
        </p:xfrm>
        <a:graphic>
          <a:graphicData uri="http://schemas.openxmlformats.org/drawingml/2006/table">
            <a:tbl>
              <a:tblPr/>
              <a:tblGrid>
                <a:gridCol w="638611"/>
                <a:gridCol w="638611"/>
                <a:gridCol w="638611"/>
                <a:gridCol w="638611"/>
                <a:gridCol w="638611"/>
                <a:gridCol w="638611"/>
                <a:gridCol w="638611"/>
                <a:gridCol w="638611"/>
              </a:tblGrid>
              <a:tr h="359219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pt-PT" sz="700" b="1" i="0" u="none" strike="noStrike" dirty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PROLIFERATION</a:t>
                      </a:r>
                    </a:p>
                  </a:txBody>
                  <a:tcPr marL="5987" marR="5987" marT="598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pt-P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CYTOSKELETON ORGANIZATION</a:t>
                      </a:r>
                    </a:p>
                  </a:txBody>
                  <a:tcPr marL="5987" marR="5987" marT="598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CELL INTEGRITY/ CELL DEATH</a:t>
                      </a:r>
                    </a:p>
                  </a:txBody>
                  <a:tcPr marL="5987" marR="5987" marT="598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OXIDATIVE STRESS</a:t>
                      </a:r>
                    </a:p>
                  </a:txBody>
                  <a:tcPr marL="5987" marR="5987" marT="598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PARACRINE SIGNALING/ REGENERATION</a:t>
                      </a:r>
                    </a:p>
                  </a:txBody>
                  <a:tcPr marL="5987" marR="5987" marT="598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STRESS RESPONSE</a:t>
                      </a:r>
                    </a:p>
                  </a:txBody>
                  <a:tcPr marL="5987" marR="5987" marT="598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METABOLISM</a:t>
                      </a:r>
                    </a:p>
                  </a:txBody>
                  <a:tcPr marL="5987" marR="5987" marT="598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119740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pt-PT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(N=83)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pt-P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(N=39)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(N=38)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(N=11)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(N=20)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(N=16)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(N=10)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ATF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F2D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NP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OD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OA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OA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SP8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HCYL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F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ER1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XN3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ID1A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OD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OD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RB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PGM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OD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NA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C42SE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F1A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PX7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OH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NAQ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H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OH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UFAF2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D3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SP8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AK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SP8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PX7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PDH5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ID1A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KB2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GA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NH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KB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RADD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GF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PX3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C10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UBP1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MP1B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X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K3R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GF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AK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PX7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PSCR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P1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YTH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PF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PPR10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NAQ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F2D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GST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AP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4KA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LC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PH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KCA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LA-B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GST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T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SP8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K3R1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PB4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USP14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HOB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GFBP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UFAF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GAM4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NH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KD2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XOC8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GF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BE2J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AK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NX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MT3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PG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KP1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GF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IP1L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BE2L6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KB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PP1R10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KN2AIP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LR2K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NBP1L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PR180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K3R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KCA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GA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PP1R10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NAQ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GF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KCA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FN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MP18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G4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LA-B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GFBP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SA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OK3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OT7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KCA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QGAP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AG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PS6KB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QCR1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H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TPN9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IF20B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AK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PINF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NN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X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TPRR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IF5A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IF1A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FN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APK3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CGAP1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RT13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IF5A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HK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X4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SA1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RT4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MTOR13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T5A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LC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HOB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RT7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SH5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V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PF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S6KB2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SR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KB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PPK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PINB3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KB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A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XOC8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PINE2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4KA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P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DFT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PINF1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K3R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K3R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GF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FN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KCA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LR2K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IP1L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NW1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SS3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KCA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NAQ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HK1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CGAP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TPN9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PN3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T5A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SA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SA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PX3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EAP3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HOB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PS6KB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GF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PV3L1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PS6KB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PINE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GFBP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YMPK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PINF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FN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GHG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P2B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HK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GPP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GKC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BE2J1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T5A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NW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QGAP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BE2L6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MN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HK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AG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SP16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NN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YMPK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AK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TP20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MP7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OK3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IF1A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MP7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V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P2B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IF20B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V2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DR5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PS1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LC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MP1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NK1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MB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DR5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GALS7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NK1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92200"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BD2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87" marR="5987" marT="598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92514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5</TotalTime>
  <Words>271</Words>
  <Application>Microsoft Office PowerPoint</Application>
  <PresentationFormat>Custom</PresentationFormat>
  <Paragraphs>35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 João Sebastião</dc:creator>
  <cp:lastModifiedBy>Maria João Sebastião</cp:lastModifiedBy>
  <cp:revision>17</cp:revision>
  <dcterms:created xsi:type="dcterms:W3CDTF">2019-01-08T14:28:36Z</dcterms:created>
  <dcterms:modified xsi:type="dcterms:W3CDTF">2019-01-30T14:41:25Z</dcterms:modified>
</cp:coreProperties>
</file>